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61" r:id="rId3"/>
    <p:sldId id="262" r:id="rId4"/>
    <p:sldId id="263" r:id="rId5"/>
    <p:sldId id="264" r:id="rId6"/>
    <p:sldId id="265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1896" y="1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2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9048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41815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938326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2627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5455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2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F5E34AD-BF6A-465B-BBBC-74546A8470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8414" y="752510"/>
            <a:ext cx="4931006" cy="5330972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44624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xample training day (a) and competition day (b) for a competitive athlete with type 1 diabetes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54F828D-A25C-4670-B8D2-6378A6E2DB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2101" y="1481522"/>
            <a:ext cx="7375821" cy="3822948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2057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nergy substrates for exercis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28A9EA-3DF2-4F13-AA9B-D715DD18F587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888337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2057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irculating insulin levels in athletes with type 1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8D7DD93-C915-42CE-9CF3-D9F2B6F166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9145" y="1111389"/>
            <a:ext cx="7361733" cy="444869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645F017-5F92-4481-9B25-93695CD02BE5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4023178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DD5A61CE-78F0-4FC6-A507-C67FC33F0D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1995" y="2581030"/>
            <a:ext cx="6507261" cy="3240647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44624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arbohydrate intake patterns in 'athletes' with type 1 diabet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99CEEA0-806B-4A67-9334-F116C6E85C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61826" y="495501"/>
            <a:ext cx="2620348" cy="209064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13D9A4E-17B9-45C6-87DC-0A343EC2C234}"/>
              </a:ext>
            </a:extLst>
          </p:cNvPr>
          <p:cNvSpPr txBox="1"/>
          <p:nvPr/>
        </p:nvSpPr>
        <p:spPr>
          <a:xfrm>
            <a:off x="3131840" y="554012"/>
            <a:ext cx="41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D7316F-5562-447B-AA5A-D8940B4E1995}"/>
              </a:ext>
            </a:extLst>
          </p:cNvPr>
          <p:cNvSpPr txBox="1"/>
          <p:nvPr/>
        </p:nvSpPr>
        <p:spPr>
          <a:xfrm>
            <a:off x="1306981" y="2271233"/>
            <a:ext cx="41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72C168-84A3-4393-8A70-1C13395644D3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8335613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00834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oposed CGM-based targets for athletes with type 1 diabetes during training (a) and competition (b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13D8DAB-6B85-42EF-AE3F-B0EFA8D3C3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6748" y="1452497"/>
            <a:ext cx="5246527" cy="395300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86A0E7-9E92-42D7-87D0-BE85451DD67C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24042821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AB720B7-2225-4783-9E10-158AE39831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1071" y="476672"/>
            <a:ext cx="5581858" cy="5581858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44624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dditional travel considerations for athletes with type 1 diabet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958780D-4CD9-4276-869D-DB247BED7394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Riddell et al (2020) Diabetologia DOI 10.1007/s00125-020-05183-8 </a:t>
            </a:r>
          </a:p>
          <a:p>
            <a:r>
              <a:rPr lang="en-GB" sz="1200" dirty="0"/>
              <a:t>© The Authors 2020</a:t>
            </a:r>
          </a:p>
        </p:txBody>
      </p:sp>
    </p:spTree>
    <p:extLst>
      <p:ext uri="{BB962C8B-B14F-4D97-AF65-F5344CB8AC3E}">
        <p14:creationId xmlns:p14="http://schemas.microsoft.com/office/powerpoint/2010/main" val="1817028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169</Words>
  <Application>Microsoft Office PowerPoint</Application>
  <PresentationFormat>On-screen Show (4:3)</PresentationFormat>
  <Paragraphs>32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8</cp:revision>
  <dcterms:created xsi:type="dcterms:W3CDTF">2016-06-15T12:53:43Z</dcterms:created>
  <dcterms:modified xsi:type="dcterms:W3CDTF">2020-06-02T14:21:50Z</dcterms:modified>
</cp:coreProperties>
</file>